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3617"/>
  </p:normalViewPr>
  <p:slideViewPr>
    <p:cSldViewPr snapToGrid="0" snapToObjects="1">
      <p:cViewPr varScale="1">
        <p:scale>
          <a:sx n="106" d="100"/>
          <a:sy n="106" d="100"/>
        </p:scale>
        <p:origin x="1800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ericleung/Dropbox/HIF1BLI_Manuscript/May%202015%20new%20data/Growth%20Delay%20All%20Combin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dirty="0"/>
              <a:t>ME180 </a:t>
            </a:r>
            <a:r>
              <a:rPr lang="en-US" dirty="0" smtClean="0"/>
              <a:t>Radiation Growth </a:t>
            </a:r>
            <a:r>
              <a:rPr lang="en-US" dirty="0"/>
              <a:t>Delay</a:t>
            </a:r>
          </a:p>
        </c:rich>
      </c:tx>
      <c:layout>
        <c:manualLayout>
          <c:xMode val="edge"/>
          <c:yMode val="edge"/>
          <c:x val="0.363534635263103"/>
          <c:y val="0.00355062174605224"/>
        </c:manualLayout>
      </c:layout>
      <c:overlay val="1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85549799132251"/>
          <c:y val="0.139477548414556"/>
          <c:w val="0.803670871786188"/>
          <c:h val="0.803591175552395"/>
        </c:manualLayout>
      </c:layout>
      <c:scatterChart>
        <c:scatterStyle val="smoothMarker"/>
        <c:varyColors val="0"/>
        <c:ser>
          <c:idx val="6"/>
          <c:order val="0"/>
          <c:tx>
            <c:strRef>
              <c:f>'ME180 FINAL'!$A$2</c:f>
              <c:strCache>
                <c:ptCount val="1"/>
                <c:pt idx="0">
                  <c:v>WT RT</c:v>
                </c:pt>
              </c:strCache>
            </c:strRef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triang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minus"/>
            <c:errValType val="cust"/>
            <c:noEndCap val="0"/>
            <c:minus>
              <c:numRef>
                <c:f>'ME180 FINAL'!$D$42:$N$42</c:f>
                <c:numCache>
                  <c:formatCode>General</c:formatCode>
                  <c:ptCount val="11"/>
                  <c:pt idx="0">
                    <c:v>0.0</c:v>
                  </c:pt>
                  <c:pt idx="1">
                    <c:v>0.0584984235745787</c:v>
                  </c:pt>
                  <c:pt idx="2">
                    <c:v>0.0778653183379146</c:v>
                  </c:pt>
                  <c:pt idx="3">
                    <c:v>0.0811737939180357</c:v>
                  </c:pt>
                  <c:pt idx="4">
                    <c:v>0.0760283607779974</c:v>
                  </c:pt>
                  <c:pt idx="5">
                    <c:v>0.0865801077058486</c:v>
                  </c:pt>
                  <c:pt idx="6">
                    <c:v>0.0865973152090575</c:v>
                  </c:pt>
                  <c:pt idx="7">
                    <c:v>0.103471254131055</c:v>
                  </c:pt>
                  <c:pt idx="8">
                    <c:v>0.1397021536265</c:v>
                  </c:pt>
                  <c:pt idx="9">
                    <c:v>0.162074230473306</c:v>
                  </c:pt>
                  <c:pt idx="10">
                    <c:v>0.16553082327799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ME180 FINAL'!$D$3:$N$3</c:f>
              <c:numCache>
                <c:formatCode>General</c:formatCode>
                <c:ptCount val="11"/>
                <c:pt idx="0">
                  <c:v>0.0</c:v>
                </c:pt>
                <c:pt idx="1">
                  <c:v>1.0</c:v>
                </c:pt>
                <c:pt idx="2">
                  <c:v>3.0</c:v>
                </c:pt>
                <c:pt idx="3">
                  <c:v>5.0</c:v>
                </c:pt>
                <c:pt idx="4">
                  <c:v>7.0</c:v>
                </c:pt>
                <c:pt idx="5">
                  <c:v>9.0</c:v>
                </c:pt>
                <c:pt idx="6">
                  <c:v>11.0</c:v>
                </c:pt>
                <c:pt idx="7">
                  <c:v>13.0</c:v>
                </c:pt>
                <c:pt idx="8">
                  <c:v>15.0</c:v>
                </c:pt>
                <c:pt idx="9">
                  <c:v>17.0</c:v>
                </c:pt>
                <c:pt idx="10">
                  <c:v>19.0</c:v>
                </c:pt>
              </c:numCache>
            </c:numRef>
          </c:xVal>
          <c:yVal>
            <c:numRef>
              <c:f>'ME180 FINAL'!$D$15:$S$15</c:f>
              <c:numCache>
                <c:formatCode>0.0</c:formatCode>
                <c:ptCount val="16"/>
                <c:pt idx="0">
                  <c:v>1.0</c:v>
                </c:pt>
                <c:pt idx="1">
                  <c:v>1.222837622327245</c:v>
                </c:pt>
                <c:pt idx="2">
                  <c:v>1.418456897973972</c:v>
                </c:pt>
                <c:pt idx="3">
                  <c:v>1.506569939610742</c:v>
                </c:pt>
                <c:pt idx="4">
                  <c:v>1.530827988751146</c:v>
                </c:pt>
                <c:pt idx="5">
                  <c:v>1.575105570970571</c:v>
                </c:pt>
                <c:pt idx="6">
                  <c:v>1.748566064386643</c:v>
                </c:pt>
                <c:pt idx="7">
                  <c:v>1.851515227570818</c:v>
                </c:pt>
                <c:pt idx="8">
                  <c:v>2.021552844421517</c:v>
                </c:pt>
                <c:pt idx="9">
                  <c:v>2.211280682889377</c:v>
                </c:pt>
                <c:pt idx="10">
                  <c:v>2.494293798524597</c:v>
                </c:pt>
                <c:pt idx="11">
                  <c:v>2.596145975334982</c:v>
                </c:pt>
                <c:pt idx="12">
                  <c:v>2.716826424727998</c:v>
                </c:pt>
                <c:pt idx="13">
                  <c:v>2.798050146840342</c:v>
                </c:pt>
                <c:pt idx="14">
                  <c:v>2.85795472534762</c:v>
                </c:pt>
                <c:pt idx="15">
                  <c:v>0.0</c:v>
                </c:pt>
              </c:numCache>
            </c:numRef>
          </c:yVal>
          <c:smooth val="1"/>
        </c:ser>
        <c:ser>
          <c:idx val="7"/>
          <c:order val="1"/>
          <c:tx>
            <c:strRef>
              <c:f>'ME180 FINAL'!$A$25</c:f>
              <c:strCache>
                <c:ptCount val="1"/>
                <c:pt idx="0">
                  <c:v>HIF KD RT</c:v>
                </c:pt>
              </c:strCache>
            </c:strRef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minus"/>
            <c:errValType val="cust"/>
            <c:noEndCap val="0"/>
            <c:minus>
              <c:numRef>
                <c:f>'ME180 FINAL'!$D$42:$N$42</c:f>
                <c:numCache>
                  <c:formatCode>General</c:formatCode>
                  <c:ptCount val="11"/>
                  <c:pt idx="0">
                    <c:v>0.0</c:v>
                  </c:pt>
                  <c:pt idx="1">
                    <c:v>0.0584984235745787</c:v>
                  </c:pt>
                  <c:pt idx="2">
                    <c:v>0.0778653183379146</c:v>
                  </c:pt>
                  <c:pt idx="3">
                    <c:v>0.0811737939180357</c:v>
                  </c:pt>
                  <c:pt idx="4">
                    <c:v>0.0760283607779974</c:v>
                  </c:pt>
                  <c:pt idx="5">
                    <c:v>0.0865801077058486</c:v>
                  </c:pt>
                  <c:pt idx="6">
                    <c:v>0.0865973152090575</c:v>
                  </c:pt>
                  <c:pt idx="7">
                    <c:v>0.103471254131055</c:v>
                  </c:pt>
                  <c:pt idx="8">
                    <c:v>0.1397021536265</c:v>
                  </c:pt>
                  <c:pt idx="9">
                    <c:v>0.162074230473306</c:v>
                  </c:pt>
                  <c:pt idx="10">
                    <c:v>0.16553082327799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ME180 FINAL'!$D$26:$N$26</c:f>
              <c:numCache>
                <c:formatCode>General</c:formatCode>
                <c:ptCount val="11"/>
                <c:pt idx="0">
                  <c:v>0.0</c:v>
                </c:pt>
                <c:pt idx="1">
                  <c:v>1.0</c:v>
                </c:pt>
                <c:pt idx="2">
                  <c:v>3.0</c:v>
                </c:pt>
                <c:pt idx="3">
                  <c:v>5.0</c:v>
                </c:pt>
                <c:pt idx="4">
                  <c:v>7.0</c:v>
                </c:pt>
                <c:pt idx="5">
                  <c:v>9.0</c:v>
                </c:pt>
                <c:pt idx="6">
                  <c:v>11.0</c:v>
                </c:pt>
                <c:pt idx="7">
                  <c:v>13.0</c:v>
                </c:pt>
                <c:pt idx="8">
                  <c:v>15.0</c:v>
                </c:pt>
                <c:pt idx="9">
                  <c:v>17.0</c:v>
                </c:pt>
                <c:pt idx="10">
                  <c:v>19.0</c:v>
                </c:pt>
              </c:numCache>
            </c:numRef>
          </c:xVal>
          <c:yVal>
            <c:numRef>
              <c:f>'ME180 FINAL'!$D$38:$N$38</c:f>
              <c:numCache>
                <c:formatCode>0.000</c:formatCode>
                <c:ptCount val="11"/>
                <c:pt idx="0">
                  <c:v>1.0</c:v>
                </c:pt>
                <c:pt idx="1">
                  <c:v>1.120958629985335</c:v>
                </c:pt>
                <c:pt idx="2">
                  <c:v>1.265038325820449</c:v>
                </c:pt>
                <c:pt idx="3">
                  <c:v>1.426626848075663</c:v>
                </c:pt>
                <c:pt idx="4">
                  <c:v>1.492220288657288</c:v>
                </c:pt>
                <c:pt idx="5">
                  <c:v>1.533306575717863</c:v>
                </c:pt>
                <c:pt idx="6">
                  <c:v>1.586594511678838</c:v>
                </c:pt>
                <c:pt idx="7">
                  <c:v>1.790247805656781</c:v>
                </c:pt>
                <c:pt idx="8">
                  <c:v>2.016606795691606</c:v>
                </c:pt>
                <c:pt idx="9">
                  <c:v>2.221824384984496</c:v>
                </c:pt>
                <c:pt idx="10">
                  <c:v>2.346691944737392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ME180 HYPOXIA FINAL(NORMALIZED)'!$A$1</c:f>
              <c:strCache>
                <c:ptCount val="1"/>
                <c:pt idx="0">
                  <c:v>WT RT Hypoxia</c:v>
                </c:pt>
              </c:strCache>
            </c:strRef>
          </c:tx>
          <c:spPr>
            <a:ln w="25400">
              <a:solidFill>
                <a:srgbClr val="FF0000"/>
              </a:solidFill>
              <a:prstDash val="solid"/>
            </a:ln>
          </c:spPr>
          <c:marker>
            <c:symbol val="triangle"/>
            <c:size val="7"/>
            <c:spPr>
              <a:solidFill>
                <a:srgbClr val="FF0000"/>
              </a:solidFill>
              <a:ln>
                <a:solidFill>
                  <a:srgbClr val="FF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E180 HYPOXIA FINAL(NORMALIZED)'!$D$16:$S$16</c:f>
                <c:numCache>
                  <c:formatCode>General</c:formatCode>
                  <c:ptCount val="16"/>
                  <c:pt idx="0">
                    <c:v>0.0</c:v>
                  </c:pt>
                  <c:pt idx="1">
                    <c:v>0.0242743178444966</c:v>
                  </c:pt>
                  <c:pt idx="2">
                    <c:v>0.0569944604595631</c:v>
                  </c:pt>
                  <c:pt idx="3">
                    <c:v>0.0432705574659733</c:v>
                  </c:pt>
                  <c:pt idx="4">
                    <c:v>0.0325060281989124</c:v>
                  </c:pt>
                  <c:pt idx="5">
                    <c:v>0.0347671938730297</c:v>
                  </c:pt>
                  <c:pt idx="6">
                    <c:v>0.0689347995616953</c:v>
                  </c:pt>
                  <c:pt idx="7">
                    <c:v>0.114048377872216</c:v>
                  </c:pt>
                  <c:pt idx="8">
                    <c:v>0.147641608763332</c:v>
                  </c:pt>
                  <c:pt idx="9">
                    <c:v>0.160077465112784</c:v>
                  </c:pt>
                  <c:pt idx="10">
                    <c:v>0.176102934200821</c:v>
                  </c:pt>
                  <c:pt idx="11">
                    <c:v>0.183094384737816</c:v>
                  </c:pt>
                  <c:pt idx="12">
                    <c:v>0.176275592320902</c:v>
                  </c:pt>
                  <c:pt idx="13">
                    <c:v>0.183116027669249</c:v>
                  </c:pt>
                  <c:pt idx="14">
                    <c:v>0.181326934336339</c:v>
                  </c:pt>
                  <c:pt idx="15">
                    <c:v>0.210644925566649</c:v>
                  </c:pt>
                </c:numCache>
              </c:numRef>
            </c:plus>
            <c:minus>
              <c:numRef>
                <c:f>'ME180 HYPOXIA FINAL(NORMALIZED)'!$D$16:$S$16</c:f>
                <c:numCache>
                  <c:formatCode>General</c:formatCode>
                  <c:ptCount val="16"/>
                  <c:pt idx="0">
                    <c:v>0.0</c:v>
                  </c:pt>
                  <c:pt idx="1">
                    <c:v>0.0242743178444966</c:v>
                  </c:pt>
                  <c:pt idx="2">
                    <c:v>0.0569944604595631</c:v>
                  </c:pt>
                  <c:pt idx="3">
                    <c:v>0.0432705574659733</c:v>
                  </c:pt>
                  <c:pt idx="4">
                    <c:v>0.0325060281989124</c:v>
                  </c:pt>
                  <c:pt idx="5">
                    <c:v>0.0347671938730297</c:v>
                  </c:pt>
                  <c:pt idx="6">
                    <c:v>0.0689347995616953</c:v>
                  </c:pt>
                  <c:pt idx="7">
                    <c:v>0.114048377872216</c:v>
                  </c:pt>
                  <c:pt idx="8">
                    <c:v>0.147641608763332</c:v>
                  </c:pt>
                  <c:pt idx="9">
                    <c:v>0.160077465112784</c:v>
                  </c:pt>
                  <c:pt idx="10">
                    <c:v>0.176102934200821</c:v>
                  </c:pt>
                  <c:pt idx="11">
                    <c:v>0.183094384737816</c:v>
                  </c:pt>
                  <c:pt idx="12">
                    <c:v>0.176275592320902</c:v>
                  </c:pt>
                  <c:pt idx="13">
                    <c:v>0.183116027669249</c:v>
                  </c:pt>
                  <c:pt idx="14">
                    <c:v>0.181326934336339</c:v>
                  </c:pt>
                  <c:pt idx="15">
                    <c:v>0.21064492556664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ME180 HYPOXIA FINAL(NORMALIZED)'!$D$2:$S$2</c:f>
              <c:numCache>
                <c:formatCode>General</c:formatCode>
                <c:ptCount val="16"/>
                <c:pt idx="0">
                  <c:v>0.0</c:v>
                </c:pt>
                <c:pt idx="1">
                  <c:v>1.0</c:v>
                </c:pt>
                <c:pt idx="2">
                  <c:v>3.0</c:v>
                </c:pt>
                <c:pt idx="3">
                  <c:v>5.0</c:v>
                </c:pt>
                <c:pt idx="4">
                  <c:v>7.0</c:v>
                </c:pt>
                <c:pt idx="5">
                  <c:v>9.0</c:v>
                </c:pt>
                <c:pt idx="6">
                  <c:v>11.0</c:v>
                </c:pt>
                <c:pt idx="7">
                  <c:v>13.0</c:v>
                </c:pt>
                <c:pt idx="8">
                  <c:v>15.0</c:v>
                </c:pt>
                <c:pt idx="9">
                  <c:v>17.0</c:v>
                </c:pt>
                <c:pt idx="10">
                  <c:v>19.0</c:v>
                </c:pt>
                <c:pt idx="11">
                  <c:v>21.0</c:v>
                </c:pt>
                <c:pt idx="12">
                  <c:v>23.0</c:v>
                </c:pt>
                <c:pt idx="13">
                  <c:v>25.0</c:v>
                </c:pt>
                <c:pt idx="14">
                  <c:v>27.0</c:v>
                </c:pt>
                <c:pt idx="15">
                  <c:v>29.0</c:v>
                </c:pt>
              </c:numCache>
            </c:numRef>
          </c:xVal>
          <c:yVal>
            <c:numRef>
              <c:f>'ME180 HYPOXIA FINAL(NORMALIZED)'!$D$14:$S$14</c:f>
              <c:numCache>
                <c:formatCode>0.0</c:formatCode>
                <c:ptCount val="16"/>
                <c:pt idx="0">
                  <c:v>1.0</c:v>
                </c:pt>
                <c:pt idx="1">
                  <c:v>1.126518975114887</c:v>
                </c:pt>
                <c:pt idx="2">
                  <c:v>1.316028900009387</c:v>
                </c:pt>
                <c:pt idx="3">
                  <c:v>1.434054052126788</c:v>
                </c:pt>
                <c:pt idx="4">
                  <c:v>1.578547560453777</c:v>
                </c:pt>
                <c:pt idx="5">
                  <c:v>1.715678919089607</c:v>
                </c:pt>
                <c:pt idx="6">
                  <c:v>1.779275850419311</c:v>
                </c:pt>
                <c:pt idx="7">
                  <c:v>1.986938077522835</c:v>
                </c:pt>
                <c:pt idx="8">
                  <c:v>2.247733115814863</c:v>
                </c:pt>
                <c:pt idx="9">
                  <c:v>2.703934350879897</c:v>
                </c:pt>
                <c:pt idx="10">
                  <c:v>2.903019470788046</c:v>
                </c:pt>
                <c:pt idx="11">
                  <c:v>3.017885862658912</c:v>
                </c:pt>
                <c:pt idx="12">
                  <c:v>3.038513107933492</c:v>
                </c:pt>
                <c:pt idx="13">
                  <c:v>3.225388016557442</c:v>
                </c:pt>
                <c:pt idx="14">
                  <c:v>3.327789877145722</c:v>
                </c:pt>
                <c:pt idx="15">
                  <c:v>3.42210365838102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ME180 HYPOXIA FINAL(NORMALIZED)'!$A$18</c:f>
              <c:strCache>
                <c:ptCount val="1"/>
                <c:pt idx="0">
                  <c:v>HIF-1 KD RT Hypoxia</c:v>
                </c:pt>
              </c:strCache>
            </c:strRef>
          </c:tx>
          <c:spPr>
            <a:ln w="25400">
              <a:solidFill>
                <a:schemeClr val="tx1"/>
              </a:solidFill>
              <a:prstDash val="sysDot"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E180 HYPOXIA FINAL(NORMALIZED)'!$D$16:$S$16</c:f>
                <c:numCache>
                  <c:formatCode>General</c:formatCode>
                  <c:ptCount val="16"/>
                  <c:pt idx="0">
                    <c:v>0.0</c:v>
                  </c:pt>
                  <c:pt idx="1">
                    <c:v>0.0242743178444966</c:v>
                  </c:pt>
                  <c:pt idx="2">
                    <c:v>0.0569944604595631</c:v>
                  </c:pt>
                  <c:pt idx="3">
                    <c:v>0.0432705574659733</c:v>
                  </c:pt>
                  <c:pt idx="4">
                    <c:v>0.0325060281989124</c:v>
                  </c:pt>
                  <c:pt idx="5">
                    <c:v>0.0347671938730297</c:v>
                  </c:pt>
                  <c:pt idx="6">
                    <c:v>0.0689347995616953</c:v>
                  </c:pt>
                  <c:pt idx="7">
                    <c:v>0.114048377872216</c:v>
                  </c:pt>
                  <c:pt idx="8">
                    <c:v>0.147641608763332</c:v>
                  </c:pt>
                  <c:pt idx="9">
                    <c:v>0.160077465112784</c:v>
                  </c:pt>
                  <c:pt idx="10">
                    <c:v>0.176102934200821</c:v>
                  </c:pt>
                  <c:pt idx="11">
                    <c:v>0.183094384737816</c:v>
                  </c:pt>
                  <c:pt idx="12">
                    <c:v>0.176275592320902</c:v>
                  </c:pt>
                  <c:pt idx="13">
                    <c:v>0.183116027669249</c:v>
                  </c:pt>
                  <c:pt idx="14">
                    <c:v>0.181326934336339</c:v>
                  </c:pt>
                  <c:pt idx="15">
                    <c:v>0.210644925566649</c:v>
                  </c:pt>
                </c:numCache>
              </c:numRef>
            </c:plus>
            <c:minus>
              <c:numRef>
                <c:f>'ME180 HYPOXIA FINAL(NORMALIZED)'!$D$16:$S$16</c:f>
                <c:numCache>
                  <c:formatCode>General</c:formatCode>
                  <c:ptCount val="16"/>
                  <c:pt idx="0">
                    <c:v>0.0</c:v>
                  </c:pt>
                  <c:pt idx="1">
                    <c:v>0.0242743178444966</c:v>
                  </c:pt>
                  <c:pt idx="2">
                    <c:v>0.0569944604595631</c:v>
                  </c:pt>
                  <c:pt idx="3">
                    <c:v>0.0432705574659733</c:v>
                  </c:pt>
                  <c:pt idx="4">
                    <c:v>0.0325060281989124</c:v>
                  </c:pt>
                  <c:pt idx="5">
                    <c:v>0.0347671938730297</c:v>
                  </c:pt>
                  <c:pt idx="6">
                    <c:v>0.0689347995616953</c:v>
                  </c:pt>
                  <c:pt idx="7">
                    <c:v>0.114048377872216</c:v>
                  </c:pt>
                  <c:pt idx="8">
                    <c:v>0.147641608763332</c:v>
                  </c:pt>
                  <c:pt idx="9">
                    <c:v>0.160077465112784</c:v>
                  </c:pt>
                  <c:pt idx="10">
                    <c:v>0.176102934200821</c:v>
                  </c:pt>
                  <c:pt idx="11">
                    <c:v>0.183094384737816</c:v>
                  </c:pt>
                  <c:pt idx="12">
                    <c:v>0.176275592320902</c:v>
                  </c:pt>
                  <c:pt idx="13">
                    <c:v>0.183116027669249</c:v>
                  </c:pt>
                  <c:pt idx="14">
                    <c:v>0.181326934336339</c:v>
                  </c:pt>
                  <c:pt idx="15">
                    <c:v>0.21064492556664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'ME180 HYPOXIA FINAL(NORMALIZED)'!$D$19:$S$19</c:f>
              <c:numCache>
                <c:formatCode>General</c:formatCode>
                <c:ptCount val="16"/>
                <c:pt idx="0">
                  <c:v>0.0</c:v>
                </c:pt>
                <c:pt idx="1">
                  <c:v>1.0</c:v>
                </c:pt>
                <c:pt idx="2">
                  <c:v>3.0</c:v>
                </c:pt>
                <c:pt idx="3">
                  <c:v>5.0</c:v>
                </c:pt>
                <c:pt idx="4">
                  <c:v>7.0</c:v>
                </c:pt>
                <c:pt idx="5">
                  <c:v>9.0</c:v>
                </c:pt>
                <c:pt idx="6">
                  <c:v>11.0</c:v>
                </c:pt>
                <c:pt idx="7">
                  <c:v>13.0</c:v>
                </c:pt>
                <c:pt idx="8">
                  <c:v>15.0</c:v>
                </c:pt>
                <c:pt idx="9">
                  <c:v>17.0</c:v>
                </c:pt>
                <c:pt idx="10">
                  <c:v>19.0</c:v>
                </c:pt>
                <c:pt idx="11">
                  <c:v>21.0</c:v>
                </c:pt>
                <c:pt idx="12">
                  <c:v>23.0</c:v>
                </c:pt>
                <c:pt idx="13">
                  <c:v>25.0</c:v>
                </c:pt>
                <c:pt idx="14">
                  <c:v>27.0</c:v>
                </c:pt>
                <c:pt idx="15">
                  <c:v>29.0</c:v>
                </c:pt>
              </c:numCache>
            </c:numRef>
          </c:xVal>
          <c:yVal>
            <c:numRef>
              <c:f>'ME180 HYPOXIA FINAL(NORMALIZED)'!$D$31:$S$31</c:f>
              <c:numCache>
                <c:formatCode>0.0000</c:formatCode>
                <c:ptCount val="16"/>
                <c:pt idx="0">
                  <c:v>1.0</c:v>
                </c:pt>
                <c:pt idx="1">
                  <c:v>1.154187898619552</c:v>
                </c:pt>
                <c:pt idx="2">
                  <c:v>1.237133890049868</c:v>
                </c:pt>
                <c:pt idx="3">
                  <c:v>1.31116448717832</c:v>
                </c:pt>
                <c:pt idx="4">
                  <c:v>1.469112704743046</c:v>
                </c:pt>
                <c:pt idx="5">
                  <c:v>1.532772918488117</c:v>
                </c:pt>
                <c:pt idx="6">
                  <c:v>1.618535240241384</c:v>
                </c:pt>
                <c:pt idx="7">
                  <c:v>1.740139593647295</c:v>
                </c:pt>
                <c:pt idx="8">
                  <c:v>1.948668309013605</c:v>
                </c:pt>
                <c:pt idx="9">
                  <c:v>2.147310147228227</c:v>
                </c:pt>
                <c:pt idx="10">
                  <c:v>2.24181238066741</c:v>
                </c:pt>
                <c:pt idx="11">
                  <c:v>2.353982858546873</c:v>
                </c:pt>
                <c:pt idx="12">
                  <c:v>2.476403825309139</c:v>
                </c:pt>
                <c:pt idx="13">
                  <c:v>2.596407678596723</c:v>
                </c:pt>
                <c:pt idx="14">
                  <c:v>2.62011528297518</c:v>
                </c:pt>
                <c:pt idx="15">
                  <c:v>2.55231985931237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7820656"/>
        <c:axId val="2127825776"/>
      </c:scatterChart>
      <c:valAx>
        <c:axId val="2127820656"/>
        <c:scaling>
          <c:orientation val="minMax"/>
          <c:max val="25.0"/>
        </c:scaling>
        <c:delete val="0"/>
        <c:axPos val="b"/>
        <c:majorGridlines>
          <c:spPr>
            <a:ln w="3175">
              <a:noFill/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/>
                  <a:t>Days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127825776"/>
        <c:crosses val="autoZero"/>
        <c:crossBetween val="midCat"/>
      </c:valAx>
      <c:valAx>
        <c:axId val="2127825776"/>
        <c:scaling>
          <c:orientation val="minMax"/>
          <c:max val="4.5"/>
          <c:min val="0.5"/>
        </c:scaling>
        <c:delete val="0"/>
        <c:axPos val="l"/>
        <c:majorGridlines>
          <c:spPr>
            <a:ln w="3175">
              <a:noFill/>
              <a:prstDash val="solid"/>
            </a:ln>
          </c:spPr>
        </c:majorGridlines>
        <c:minorGridlines>
          <c:spPr>
            <a:ln w="3175">
              <a:solidFill>
                <a:srgbClr val="C0C0C0"/>
              </a:solidFill>
              <a:prstDash val="solid"/>
            </a:ln>
          </c:spPr>
        </c:minorGridlines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/>
                  <a:t>Normalized Weight 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2127820656"/>
        <c:crosses val="autoZero"/>
        <c:crossBetween val="midCat"/>
        <c:minorUnit val="0.5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190596835004745"/>
          <c:y val="0.158804951833337"/>
          <c:w val="0.340620873764443"/>
          <c:h val="0.310263643462882"/>
        </c:manualLayout>
      </c:layout>
      <c:overlay val="1"/>
      <c:spPr>
        <a:noFill/>
        <a:ln w="25400">
          <a:noFill/>
        </a:ln>
      </c:spPr>
      <c:txPr>
        <a:bodyPr/>
        <a:lstStyle/>
        <a:p>
          <a:pPr>
            <a:defRPr sz="735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9525"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E28785-4933-6B4C-871A-D0D6432FE8F9}" type="datetimeFigureOut">
              <a:rPr lang="en-US" smtClean="0"/>
              <a:t>7/3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215847-F595-F344-8F7B-DA001EB26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5003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91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80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943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145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286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912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560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899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888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06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020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77FE8-D8F6-8F4A-8A32-B81FEC6909C8}" type="datetimeFigureOut">
              <a:rPr lang="en-US" smtClean="0"/>
              <a:t>7/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2EA33C-E3C5-1745-B807-C76E911F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23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01359"/>
              </p:ext>
            </p:extLst>
          </p:nvPr>
        </p:nvGraphicFramePr>
        <p:xfrm>
          <a:off x="2147778" y="1531088"/>
          <a:ext cx="4699590" cy="42283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48856" y="127590"/>
            <a:ext cx="2319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Supplemental Figure 1</a:t>
            </a:r>
            <a:endParaRPr lang="en-US" b="1" i="1" dirty="0"/>
          </a:p>
        </p:txBody>
      </p:sp>
    </p:spTree>
    <p:extLst>
      <p:ext uri="{BB962C8B-B14F-4D97-AF65-F5344CB8AC3E}">
        <p14:creationId xmlns:p14="http://schemas.microsoft.com/office/powerpoint/2010/main" val="1154993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79</TotalTime>
  <Words>10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 L</dc:creator>
  <cp:lastModifiedBy>Eric Leung</cp:lastModifiedBy>
  <cp:revision>114</cp:revision>
  <dcterms:created xsi:type="dcterms:W3CDTF">2014-03-11T04:37:09Z</dcterms:created>
  <dcterms:modified xsi:type="dcterms:W3CDTF">2016-07-03T16:19:15Z</dcterms:modified>
</cp:coreProperties>
</file>